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0" autoAdjust="0"/>
    <p:restoredTop sz="87309" autoAdjust="0"/>
  </p:normalViewPr>
  <p:slideViewPr>
    <p:cSldViewPr>
      <p:cViewPr>
        <p:scale>
          <a:sx n="103" d="100"/>
          <a:sy n="103" d="100"/>
        </p:scale>
        <p:origin x="-1026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786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98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0374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254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6745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9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367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050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396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214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729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260B3-36FC-4212-B8F2-5B9266868F90}" type="datetimeFigureOut">
              <a:rPr lang="en-US" smtClean="0"/>
              <a:t>10/2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0480A-DD00-46F2-91BC-654BFB4AAF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901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1195864"/>
            <a:ext cx="8229600" cy="5204936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43755" y="457200"/>
            <a:ext cx="8229600" cy="73866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 smtClean="0"/>
              <a:t>Supplementary Figure 2. </a:t>
            </a:r>
            <a:r>
              <a:rPr lang="en-US" sz="1200" dirty="0" smtClean="0"/>
              <a:t>Sequential images obtained </a:t>
            </a:r>
            <a:r>
              <a:rPr lang="en-US" sz="1200" smtClean="0"/>
              <a:t>from </a:t>
            </a:r>
            <a:r>
              <a:rPr lang="en-US" sz="1200" smtClean="0"/>
              <a:t>time-lapse </a:t>
            </a:r>
            <a:r>
              <a:rPr lang="en-US" sz="1200" dirty="0" smtClean="0"/>
              <a:t>fluorescent imaging of MSDACs that were grown in SF-SCM-1 for three generations and subsequently maintained in growth medium supplemented with 10% FBS (GM-FBS) </a:t>
            </a:r>
            <a:r>
              <a:rPr lang="en-US" sz="1200" smtClean="0"/>
              <a:t>for </a:t>
            </a:r>
            <a:r>
              <a:rPr lang="en-US" sz="1200" smtClean="0"/>
              <a:t>an additional </a:t>
            </a:r>
            <a:r>
              <a:rPr lang="en-US" sz="1200" dirty="0" smtClean="0"/>
              <a:t>three generations. MSDACs cultured in SF-SCM-1 (3G)→GM-FBS(3G) showed consistent cell proliferation and monolayer spreading without any cellular aggregation or </a:t>
            </a:r>
            <a:r>
              <a:rPr lang="en-US" sz="1200" dirty="0" err="1" smtClean="0"/>
              <a:t>tumorosphere</a:t>
            </a:r>
            <a:r>
              <a:rPr lang="en-US" sz="1200" dirty="0" smtClean="0"/>
              <a:t> formation. 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374045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6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UH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vindan, Natarajan  (HSC)</dc:creator>
  <cp:lastModifiedBy>Corporate Edition</cp:lastModifiedBy>
  <cp:revision>6</cp:revision>
  <dcterms:created xsi:type="dcterms:W3CDTF">2014-10-14T21:14:23Z</dcterms:created>
  <dcterms:modified xsi:type="dcterms:W3CDTF">2014-10-21T11:29:16Z</dcterms:modified>
</cp:coreProperties>
</file>